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4" autoAdjust="0"/>
    <p:restoredTop sz="94660"/>
  </p:normalViewPr>
  <p:slideViewPr>
    <p:cSldViewPr snapToGrid="0">
      <p:cViewPr varScale="1">
        <p:scale>
          <a:sx n="48" d="100"/>
          <a:sy n="48" d="100"/>
        </p:scale>
        <p:origin x="489" y="3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B9A2FA7-32D7-460E-8EF2-430EA577F4E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3A8DD90-2E32-4A2F-A290-2AD24DA7E3A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DF51874-3D8A-46A6-BD5B-34AC9CA1F4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12BA7-D00E-4EB2-8092-F854FFB41256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A9B3116-551E-4BC1-9B90-67E6464D50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55A5229-AAC9-4EAC-984F-119F4F73D2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9B27F-10D3-4CD4-9B38-A15F060395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92818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5349AD0-9381-4D2F-9C1C-E72E994376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5D82202-478F-4D19-8629-05A2F0CDB6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FE55651-B1E4-416B-A0F4-B79C27314B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12BA7-D00E-4EB2-8092-F854FFB41256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4219EA7-87B8-446F-87B8-595716B80E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04B6718-5FAE-4889-81C0-8365AA29B5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9B27F-10D3-4CD4-9B38-A15F060395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79330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80EB66B7-B4E8-4FB3-867C-23F091BD7A2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6DB695B-70F6-4E85-9291-1FA3CD80CB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B1617FF-710F-4BB9-9E7F-FBFEB40A05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12BA7-D00E-4EB2-8092-F854FFB41256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DD3C25E-466E-4EAC-AF44-A9F7136F79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CC8B7FF-8334-4E7A-BAAE-2B31E88D00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9B27F-10D3-4CD4-9B38-A15F060395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61518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C0BD902-C79B-4EEB-A7B6-084F219FBD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228F0E7-0854-42E0-9605-37BBDBDD8CC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D5CFF80-62E2-4B8E-A7F8-281A5CF5CF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12BA7-D00E-4EB2-8092-F854FFB41256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876A29E-C047-41A0-8923-604FFBA82B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9513172-8D5D-4E51-9B23-3962B7B4A7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9B27F-10D3-4CD4-9B38-A15F060395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9053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104BA2D-3E54-4AF9-A851-280045CDEC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FE45C84-DD4D-4135-B007-6ADEBF6FEE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A260690-849D-4495-B6CA-399AB4A27E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12BA7-D00E-4EB2-8092-F854FFB41256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4BCA733-A139-47C5-981D-6A6CCA530B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01C1B18-EDEB-49AC-8674-FE0CB5963F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9B27F-10D3-4CD4-9B38-A15F060395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12351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B9E33CB-6D3F-4314-BBAD-F885489418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F394C4B-2E0B-4741-8738-90E41A52E48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72F0907-AAF1-4C69-9C81-F0956E37BC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3891D21-6CBB-426D-B355-02B1489D64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12BA7-D00E-4EB2-8092-F854FFB41256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B9CBF7A-4BC1-4A3B-80C7-95DF6A80CB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11EA890-6B08-4006-BB0B-94E528434F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9B27F-10D3-4CD4-9B38-A15F060395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42251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886C366-56ED-41F1-B525-E38602817C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52EBDDC-FC82-480D-B45A-C8B4824CF0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3AF2918-E620-4A1C-A095-36B57AE51D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F9DD7E1-B6DC-4A06-8245-83A0526DF42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04AE2B1C-6BC2-41D9-8138-0E90B21E8AD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E7DEDC07-6ADD-4E66-817F-DC6163115D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12BA7-D00E-4EB2-8092-F854FFB41256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FFDCAA56-10B1-4AD2-A36D-807D7FFD89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79E7C822-48E6-462F-B6C6-25283A91BF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9B27F-10D3-4CD4-9B38-A15F060395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13734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13D0C3F-B671-4430-8871-A8E630C011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4CABE45-DE73-4DED-9507-274F58F353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12BA7-D00E-4EB2-8092-F854FFB41256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3C9863C-9D6D-439C-A133-17E11780BE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E9D1D06-04FD-4F08-A242-862530FDBB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9B27F-10D3-4CD4-9B38-A15F060395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09027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55552F4-CAAA-4A14-91B4-A873FAF8E0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12BA7-D00E-4EB2-8092-F854FFB41256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87A937F8-0990-4329-AAE6-C82387C0C4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D919B7E5-D5D4-45C1-81AC-3B0FB63FC2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9B27F-10D3-4CD4-9B38-A15F060395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27811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8B579E5-2909-40C4-97A6-2F141FBE91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EC08234-D82A-42D0-8125-1C93FC6EF44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F63DE3C-97C4-44C7-A317-89442DF145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907246F-EC82-446A-8165-EF180C5EDC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12BA7-D00E-4EB2-8092-F854FFB41256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85B3585-7CEA-4E5E-9896-FFAC715CD0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35E17C2-B955-4D13-AEF2-28B12F7D0A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9B27F-10D3-4CD4-9B38-A15F060395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39897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19ED4F6-4717-400E-A67E-6ED8475352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19BDB28-DC23-42D7-B4FC-12E70830BA7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4FFBD85-4DEF-45A7-B92E-71A343D1E7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E65E52C-508B-42C7-90A9-6B569E156F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12BA7-D00E-4EB2-8092-F854FFB41256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F59F438-944F-4141-B1E1-7DE3053E00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9DF7B0F-0B31-4CCB-A7B1-C2E12DF9D7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9B27F-10D3-4CD4-9B38-A15F060395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67586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24E60BB-1657-4E84-9391-2DB5917771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DACC028-3097-4911-B1B1-0AF9DD0E38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7D5D39B-092D-4362-BCC8-D2D3B0159FC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212BA7-D00E-4EB2-8092-F854FFB41256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7B010B9-EABE-4E49-908C-C4471C66ED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1B95BB8-2131-4DE6-8EC3-E9E43D4529E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A9B27F-10D3-4CD4-9B38-A15F060395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10279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E1EA0821-4D21-4FDE-9D2B-0CD8CB47EDD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52544" y="1653540"/>
            <a:ext cx="3486912" cy="355092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BEC7D455-FA5A-42D0-93ED-C0BBB21BBD5E}"/>
              </a:ext>
            </a:extLst>
          </p:cNvPr>
          <p:cNvSpPr txBox="1"/>
          <p:nvPr/>
        </p:nvSpPr>
        <p:spPr>
          <a:xfrm>
            <a:off x="2820954" y="5480180"/>
            <a:ext cx="717213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kern="1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l </a:t>
            </a:r>
            <a:r>
              <a:rPr lang="en-US" altLang="zh-CN" b="1" kern="10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</a:t>
            </a:r>
            <a:r>
              <a:rPr lang="en-US" altLang="zh-CN" sz="1800" b="1" kern="1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g. </a:t>
            </a:r>
            <a:r>
              <a:rPr lang="en-US" altLang="zh-CN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overlaps of the total ion chromatogram (TIC) of each QC sample from serum in ESI+ and ESI-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593675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5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李 欢</dc:creator>
  <cp:lastModifiedBy>李 欢</cp:lastModifiedBy>
  <cp:revision>3</cp:revision>
  <dcterms:created xsi:type="dcterms:W3CDTF">2022-04-29T06:40:28Z</dcterms:created>
  <dcterms:modified xsi:type="dcterms:W3CDTF">2023-03-23T09:17:17Z</dcterms:modified>
</cp:coreProperties>
</file>